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7F02EC-F3C6-495B-8515-B6B13F0F3EF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EFD961-E6DF-4238-954E-8B44DAD183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7257EA-3CF4-47DB-BE4E-4ED2A6E5231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1EE063-249B-4574-A490-C5CF1651495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5A2364-D5A8-4754-8CEE-6FDFDF1883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6D000A-4DF5-4870-857C-060163E4DD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949D92-CEE8-4E7A-A142-8FD946119F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560297-9DDC-47CB-B7D6-E9E467DF25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2EDB00-4CBF-4D50-9415-71DEA4D680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EB21A4-4749-4BCC-953C-4BB1C4739F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F533B0-53A6-4825-AD36-2626C3C240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9E60DF-3AC8-4D93-A141-46B5057D91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B7A3D40-5D5E-4EC0-877C-8DC3AE7869B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Molecular composition and mass spectra of charged clusters during GCR nucleation events without sulfuric aci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5" descr="D:\PPT_Out\nature-logo.jpg"/>
          <p:cNvPicPr/>
          <p:nvPr/>
        </p:nvPicPr>
        <p:blipFill>
          <a:blip r:embed="rId1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3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J Kirkby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 et al.  Nature </a:t>
            </a: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533,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521–526 (2016) doi:10.1038/nature1795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Picture 6" descr="D:\Shilpa\2016\May\18\nature17953\300 dpi\nature17953-f2.jpg"/>
          <p:cNvPicPr/>
          <p:nvPr/>
        </p:nvPicPr>
        <p:blipFill>
          <a:blip r:embed="rId2"/>
          <a:stretch/>
        </p:blipFill>
        <p:spPr>
          <a:xfrm>
            <a:off x="2171880" y="1981080"/>
            <a:ext cx="4800600" cy="3130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5-04T11:33:05Z</dcterms:created>
  <dc:creator>ravikumar.n</dc:creator>
  <dc:description/>
  <dc:language>en-US</dc:language>
  <cp:lastModifiedBy>Ky.Shilpashree</cp:lastModifiedBy>
  <dcterms:modified xsi:type="dcterms:W3CDTF">2016-05-18T09:51:13Z</dcterms:modified>
  <cp:revision>11</cp:revision>
  <dc:subject/>
  <dc:title>Phylogenetic relationship of salmonids and relevant teleost lineages</dc:title>
</cp:coreProperties>
</file>